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75" d="100"/>
          <a:sy n="75" d="100"/>
        </p:scale>
        <p:origin x="3174" y="-6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0012-7F6B-45B3-A2BB-4C262F7ADB56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1C60-EF10-4C14-8E83-3164C2857D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75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0012-7F6B-45B3-A2BB-4C262F7ADB56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1C60-EF10-4C14-8E83-3164C2857D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0091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0012-7F6B-45B3-A2BB-4C262F7ADB56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1C60-EF10-4C14-8E83-3164C2857D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7999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0012-7F6B-45B3-A2BB-4C262F7ADB56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1C60-EF10-4C14-8E83-3164C2857D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69005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0012-7F6B-45B3-A2BB-4C262F7ADB56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1C60-EF10-4C14-8E83-3164C2857D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16258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0012-7F6B-45B3-A2BB-4C262F7ADB56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1C60-EF10-4C14-8E83-3164C2857D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94817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0012-7F6B-45B3-A2BB-4C262F7ADB56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1C60-EF10-4C14-8E83-3164C2857D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37943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0012-7F6B-45B3-A2BB-4C262F7ADB56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1C60-EF10-4C14-8E83-3164C2857D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53236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0012-7F6B-45B3-A2BB-4C262F7ADB56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1C60-EF10-4C14-8E83-3164C2857D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86441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0012-7F6B-45B3-A2BB-4C262F7ADB56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1C60-EF10-4C14-8E83-3164C2857D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54921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DD10012-7F6B-45B3-A2BB-4C262F7ADB56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86E1C60-EF10-4C14-8E83-3164C2857D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1246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D10012-7F6B-45B3-A2BB-4C262F7ADB56}" type="datetimeFigureOut">
              <a:rPr lang="zh-CN" altLang="en-US" smtClean="0"/>
              <a:t>2025/12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6E1C60-EF10-4C14-8E83-3164C2857D9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65196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.png"/><Relationship Id="rId3" Type="http://schemas.microsoft.com/office/2007/relationships/media" Target="../media/media2.mp4"/><Relationship Id="rId7" Type="http://schemas.openxmlformats.org/officeDocument/2006/relationships/slideLayout" Target="../slideLayouts/slideLayout1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5" Type="http://schemas.microsoft.com/office/2007/relationships/media" Target="../media/media3.mp4"/><Relationship Id="rId10" Type="http://schemas.openxmlformats.org/officeDocument/2006/relationships/image" Target="../media/image4.png"/><Relationship Id="rId4" Type="http://schemas.openxmlformats.org/officeDocument/2006/relationships/video" Target="../media/media2.mp4"/><Relationship Id="rId9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B8AB8738-1705-5CE0-FF6D-C004F02AAC2C}"/>
              </a:ext>
            </a:extLst>
          </p:cNvPr>
          <p:cNvSpPr txBox="1"/>
          <p:nvPr/>
        </p:nvSpPr>
        <p:spPr>
          <a:xfrm>
            <a:off x="604" y="249193"/>
            <a:ext cx="6857396" cy="22467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Figure S1 Determination of optimal LPS treatment conditions for inducing inflammatory responses in RAW264.7 cells.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(A-E) RAW264.7 cells were treated with different concentrations of LPS for 12 hours. (A) Representative images of western blot for p65 and p-p65. (B) Relative immunoreactivity of p-p65/p65 was quantified. mRNA expression levels of (C) </a:t>
            </a:r>
            <a:r>
              <a:rPr lang="en-US" altLang="zh-CN" sz="1400" i="1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nf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(D) </a:t>
            </a:r>
            <a:r>
              <a:rPr lang="en-US" altLang="zh-CN" sz="14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os2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and (E) </a:t>
            </a:r>
            <a:r>
              <a:rPr lang="en-US" altLang="zh-CN" sz="14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x2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ere measured by real-time PCR. (F-J) RAW264.7 cells were treated with 0.1 µg/mL LPS for different times. (F) Representative images of western blot for p65 and p-p65. (G) Relative immunoreactivity of p-p65/p65 was quantified. mRNA expression levels of (H) </a:t>
            </a:r>
            <a:r>
              <a:rPr lang="en-US" altLang="zh-CN" sz="1400" i="1" dirty="0" err="1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Tnf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(I) </a:t>
            </a:r>
            <a:r>
              <a:rPr lang="en-US" altLang="zh-CN" sz="14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Nos2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, and (J) </a:t>
            </a:r>
            <a:r>
              <a:rPr lang="en-US" altLang="zh-CN" sz="14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Cox2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were measured by real-time PCR. Values represent the mean 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  <a:sym typeface="Symbol" panose="05050102010706020507" pitchFamily="18" charset="2"/>
              </a:rPr>
              <a:t>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SEM, n = 3 per group. The results were analyzed by one-way ANOVA. *</a:t>
            </a:r>
            <a:r>
              <a:rPr lang="en-US" altLang="zh-CN" sz="14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&lt; 0.05, **</a:t>
            </a:r>
            <a:r>
              <a:rPr lang="en-US" altLang="zh-CN" sz="14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&lt; 0.01 and ***</a:t>
            </a:r>
            <a:r>
              <a:rPr lang="en-US" altLang="zh-CN" sz="1400" i="1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altLang="zh-CN" sz="14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&lt; 0.001.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6" name="图片 95">
            <a:extLst>
              <a:ext uri="{FF2B5EF4-FFF2-40B4-BE49-F238E27FC236}">
                <a16:creationId xmlns:a16="http://schemas.microsoft.com/office/drawing/2014/main" id="{BDAF4C58-DB78-F16F-6EA4-497B4DEA940F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074" r="3535"/>
          <a:stretch/>
        </p:blipFill>
        <p:spPr>
          <a:xfrm>
            <a:off x="0" y="2628900"/>
            <a:ext cx="6842644" cy="938739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820031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B8AB8738-1705-5CE0-FF6D-C004F02AAC2C}"/>
              </a:ext>
            </a:extLst>
          </p:cNvPr>
          <p:cNvSpPr txBox="1"/>
          <p:nvPr/>
        </p:nvSpPr>
        <p:spPr>
          <a:xfrm>
            <a:off x="604" y="249193"/>
            <a:ext cx="6857396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ea typeface="等线" panose="02010600030101010101" pitchFamily="2" charset="-122"/>
              </a:rPr>
              <a:t>Supplementary Figure S2 3D model video of Iba1 positive microglia. 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</a:rPr>
              <a:t>(A) Representative microglia in WT + H</a:t>
            </a:r>
            <a:r>
              <a:rPr lang="en-US" altLang="zh-CN" sz="1400" baseline="-25000" dirty="0">
                <a:latin typeface="Times New Roman" panose="02020603050405020304" pitchFamily="18" charset="0"/>
                <a:ea typeface="等线" panose="02010600030101010101" pitchFamily="2" charset="-122"/>
              </a:rPr>
              <a:t>2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</a:rPr>
              <a:t>O group. (B) Representative microglia in APP/PS1 + H</a:t>
            </a:r>
            <a:r>
              <a:rPr lang="en-US" altLang="zh-CN" sz="1400" baseline="-25000" dirty="0">
                <a:latin typeface="Times New Roman" panose="02020603050405020304" pitchFamily="18" charset="0"/>
                <a:ea typeface="等线" panose="02010600030101010101" pitchFamily="2" charset="-122"/>
              </a:rPr>
              <a:t>2</a:t>
            </a:r>
            <a:r>
              <a:rPr lang="en-US" altLang="zh-CN" sz="1400" dirty="0">
                <a:latin typeface="Times New Roman" panose="02020603050405020304" pitchFamily="18" charset="0"/>
                <a:ea typeface="等线" panose="02010600030101010101" pitchFamily="2" charset="-122"/>
              </a:rPr>
              <a:t>O group. (C) Representative microglia in APP/PS1 + SLP group.</a:t>
            </a:r>
            <a:endParaRPr lang="zh-CN" altLang="en-US" sz="1400" dirty="0"/>
          </a:p>
        </p:txBody>
      </p:sp>
      <p:pic>
        <p:nvPicPr>
          <p:cNvPr id="6" name="Fig.S1-A">
            <a:hlinkClick r:id="" action="ppaction://media"/>
            <a:extLst>
              <a:ext uri="{FF2B5EF4-FFF2-40B4-BE49-F238E27FC236}">
                <a16:creationId xmlns:a16="http://schemas.microsoft.com/office/drawing/2014/main" id="{7765FE3D-182C-6466-7CD0-D0D5BE5D0850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729000" y="1082746"/>
            <a:ext cx="5400000" cy="3037501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5A959239-D1B7-A464-82A4-5936CD6A0E32}"/>
              </a:ext>
            </a:extLst>
          </p:cNvPr>
          <p:cNvSpPr txBox="1"/>
          <p:nvPr/>
        </p:nvSpPr>
        <p:spPr>
          <a:xfrm>
            <a:off x="225683" y="4428134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endParaRPr lang="zh-CN" altLang="en-US" b="1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62AA7035-6AAC-D157-3EB7-244384FEE6C3}"/>
              </a:ext>
            </a:extLst>
          </p:cNvPr>
          <p:cNvSpPr txBox="1"/>
          <p:nvPr/>
        </p:nvSpPr>
        <p:spPr>
          <a:xfrm>
            <a:off x="225683" y="7946495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endParaRPr lang="zh-CN" altLang="en-US" b="1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B363AA3D-6DC3-E1C1-508F-B482CCFFA4F3}"/>
              </a:ext>
            </a:extLst>
          </p:cNvPr>
          <p:cNvSpPr txBox="1"/>
          <p:nvPr/>
        </p:nvSpPr>
        <p:spPr>
          <a:xfrm>
            <a:off x="225683" y="980415"/>
            <a:ext cx="360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altLang="en-US" b="1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11" name="Fig.S1-B">
            <a:hlinkClick r:id="" action="ppaction://media"/>
            <a:extLst>
              <a:ext uri="{FF2B5EF4-FFF2-40B4-BE49-F238E27FC236}">
                <a16:creationId xmlns:a16="http://schemas.microsoft.com/office/drawing/2014/main" id="{BF3F1564-69BD-6A10-A0D3-9B38A13C312A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729000" y="4577250"/>
            <a:ext cx="5400000" cy="3037500"/>
          </a:xfrm>
          <a:prstGeom prst="rect">
            <a:avLst/>
          </a:prstGeom>
        </p:spPr>
      </p:pic>
      <p:pic>
        <p:nvPicPr>
          <p:cNvPr id="12" name="Fig.S1-C">
            <a:hlinkClick r:id="" action="ppaction://media"/>
            <a:extLst>
              <a:ext uri="{FF2B5EF4-FFF2-40B4-BE49-F238E27FC236}">
                <a16:creationId xmlns:a16="http://schemas.microsoft.com/office/drawing/2014/main" id="{06187314-A4A7-D354-0C6C-A79C0607671C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729000" y="8131161"/>
            <a:ext cx="5400000" cy="3037500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0B162DFD-8BBE-CCA0-6AD6-A416534A02D5}"/>
              </a:ext>
            </a:extLst>
          </p:cNvPr>
          <p:cNvSpPr txBox="1"/>
          <p:nvPr/>
        </p:nvSpPr>
        <p:spPr>
          <a:xfrm>
            <a:off x="734591" y="1102065"/>
            <a:ext cx="1327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ba1</a:t>
            </a:r>
          </a:p>
          <a:p>
            <a:r>
              <a:rPr lang="en-US" altLang="zh-CN" sz="1200" b="1" dirty="0">
                <a:solidFill>
                  <a:srgbClr val="0200F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zh-CN" altLang="en-US" sz="1200" b="1" dirty="0">
              <a:solidFill>
                <a:srgbClr val="0200F5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31062FE0-10F6-19DB-17A6-61250285A230}"/>
              </a:ext>
            </a:extLst>
          </p:cNvPr>
          <p:cNvSpPr txBox="1"/>
          <p:nvPr/>
        </p:nvSpPr>
        <p:spPr>
          <a:xfrm>
            <a:off x="734591" y="4585469"/>
            <a:ext cx="1327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ba1</a:t>
            </a:r>
          </a:p>
          <a:p>
            <a:r>
              <a:rPr lang="en-US" altLang="zh-CN" sz="1200" b="1" dirty="0">
                <a:solidFill>
                  <a:srgbClr val="0200F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zh-CN" altLang="en-US" sz="1200" b="1" dirty="0">
              <a:solidFill>
                <a:srgbClr val="0200F5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CFE9EC48-0795-3832-7193-DCD70814C4C7}"/>
              </a:ext>
            </a:extLst>
          </p:cNvPr>
          <p:cNvSpPr txBox="1"/>
          <p:nvPr/>
        </p:nvSpPr>
        <p:spPr>
          <a:xfrm>
            <a:off x="734591" y="8141448"/>
            <a:ext cx="132734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FF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ba1</a:t>
            </a:r>
          </a:p>
          <a:p>
            <a:r>
              <a:rPr lang="en-US" altLang="zh-CN" sz="1200" b="1" dirty="0">
                <a:solidFill>
                  <a:srgbClr val="0200F5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zh-CN" altLang="en-US" sz="1200" b="1" dirty="0">
              <a:solidFill>
                <a:srgbClr val="0200F5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6231429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249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8249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8249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5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16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7" fill="hold">
                      <p:stCondLst>
                        <p:cond delay="0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0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  <p:video>
              <p:cMediaNode vol="80000">
                <p:cTn id="21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  <p:seq concurrent="1" nextAc="seek">
              <p:cTn id="22" restart="whenNotActive" fill="hold" evtFilter="cancelBubble" nodeType="interactiveSeq">
                <p:stCondLst>
                  <p:cond evt="onClick" delay="0">
                    <p:tgtEl>
                      <p:spTgt spid="11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3" fill="hold">
                      <p:stCondLst>
                        <p:cond delay="0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6" dur="1" fill="hold"/>
                                        <p:tgtEl>
                                          <p:spTgt spid="11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1"/>
                  </p:tgtEl>
                </p:cond>
              </p:nextCondLst>
            </p:seq>
            <p:video>
              <p:cMediaNode vol="80000">
                <p:cTn id="27" fill="hold" display="0">
                  <p:stCondLst>
                    <p:cond delay="indefinite"/>
                  </p:stCondLst>
                </p:cTn>
                <p:tgtEl>
                  <p:spTgt spid="12"/>
                </p:tgtEl>
              </p:cMediaNode>
            </p:video>
            <p:seq concurrent="1" nextAc="seek">
              <p:cTn id="28" restart="whenNotActive" fill="hold" evtFilter="cancelBubble" nodeType="interactiveSeq">
                <p:stCondLst>
                  <p:cond evt="onClick" delay="0">
                    <p:tgtEl>
                      <p:spTgt spid="12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29" fill="hold">
                      <p:stCondLst>
                        <p:cond delay="0"/>
                      </p:stCondLst>
                      <p:childTnLst>
                        <p:par>
                          <p:cTn id="30" fill="hold">
                            <p:stCondLst>
                              <p:cond delay="0"/>
                            </p:stCondLst>
                            <p:childTnLst>
                              <p:par>
                                <p:cTn id="3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32" dur="1" fill="hold"/>
                                        <p:tgtEl>
                                          <p:spTgt spid="1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12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8</TotalTime>
  <Words>243</Words>
  <Application>Microsoft Office PowerPoint</Application>
  <PresentationFormat>Widescreen</PresentationFormat>
  <Paragraphs>11</Paragraphs>
  <Slides>2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主题​​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田田 张</dc:creator>
  <cp:lastModifiedBy>MDPI</cp:lastModifiedBy>
  <cp:revision>7</cp:revision>
  <dcterms:created xsi:type="dcterms:W3CDTF">2025-08-09T05:00:43Z</dcterms:created>
  <dcterms:modified xsi:type="dcterms:W3CDTF">2025-12-12T02:07:41Z</dcterms:modified>
</cp:coreProperties>
</file>